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19\PAF&#50836;&#51064;&#48324;&#44536;&#47548;&#44536;&#47532;&#44592;_SMK_Soseul_24062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19\PAF&#50836;&#51064;&#48324;&#44536;&#47548;&#44536;&#47532;&#44592;_SMK_Soseul_24062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19\PAF&#50836;&#51064;&#48324;&#44536;&#47548;&#44536;&#47532;&#44592;_SMK_Soseul_240624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19\PAF&#50836;&#51064;&#48324;&#44536;&#47548;&#44536;&#47532;&#44592;_SMK_Soseul_240624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19\PAF&#50836;&#51064;&#48324;&#44536;&#47548;&#44536;&#47532;&#44592;_SMK_Soseul_240624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19\PAF&#50836;&#51064;&#48324;&#44536;&#47548;&#44536;&#47532;&#44592;_SMK_Soseul_240624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AB9C-4D7A-BE3B-EA39258BDF43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AB9C-4D7A-BE3B-EA39258BDF43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AB9C-4D7A-BE3B-EA39258BDF43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AB9C-4D7A-BE3B-EA39258BDF43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15_D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남녀_2015_D!$B$1:$B$2</c:f>
              <c:numCache>
                <c:formatCode>General</c:formatCode>
                <c:ptCount val="2"/>
                <c:pt idx="0">
                  <c:v>78.3</c:v>
                </c:pt>
                <c:pt idx="1">
                  <c:v>21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B9C-4D7A-BE3B-EA39258BDF43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127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886D-4D9D-8F44-A6EF94D31BAB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886D-4D9D-8F44-A6EF94D31BAB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886D-4D9D-8F44-A6EF94D31BAB}"/>
              </c:ext>
            </c:extLst>
          </c:dPt>
          <c:dPt>
            <c:idx val="3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886D-4D9D-8F44-A6EF94D31BAB}"/>
              </c:ext>
            </c:extLst>
          </c:dPt>
          <c:dPt>
            <c:idx val="4"/>
            <c:bubble3D val="0"/>
            <c:spPr>
              <a:solidFill>
                <a:schemeClr val="dk1">
                  <a:tint val="3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886D-4D9D-8F44-A6EF94D31BAB}"/>
              </c:ext>
            </c:extLst>
          </c:dPt>
          <c:dPt>
            <c:idx val="5"/>
            <c:bubble3D val="0"/>
            <c:spPr>
              <a:solidFill>
                <a:schemeClr val="dk1">
                  <a:tint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886D-4D9D-8F44-A6EF94D31BAB}"/>
              </c:ext>
            </c:extLst>
          </c:dPt>
          <c:dPt>
            <c:idx val="6"/>
            <c:bubble3D val="0"/>
            <c:spPr>
              <a:solidFill>
                <a:schemeClr val="dk1">
                  <a:tint val="8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886D-4D9D-8F44-A6EF94D31BAB}"/>
              </c:ext>
            </c:extLst>
          </c:dPt>
          <c:dPt>
            <c:idx val="7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886D-4D9D-8F44-A6EF94D31BAB}"/>
              </c:ext>
            </c:extLst>
          </c:dPt>
          <c:dPt>
            <c:idx val="8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886D-4D9D-8F44-A6EF94D31BAB}"/>
              </c:ext>
            </c:extLst>
          </c:dPt>
          <c:dPt>
            <c:idx val="9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886D-4D9D-8F44-A6EF94D31BAB}"/>
              </c:ext>
            </c:extLst>
          </c:dPt>
          <c:dPt>
            <c:idx val="10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886D-4D9D-8F44-A6EF94D31BAB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9A358069-5A98-4D36-8568-3DB055DCD609}" type="VALU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값]</a:t>
                    </a:fld>
                    <a:r>
                      <a:rPr lang="en-US" altLang="ko-KR" baseline="0"/>
                      <a:t>%</a:t>
                    </a:r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886D-4D9D-8F44-A6EF94D31BAB}"/>
                </c:ext>
              </c:extLst>
            </c:dLbl>
            <c:dLbl>
              <c:idx val="1"/>
              <c:layout>
                <c:manualLayout>
                  <c:x val="0.2610699319822814"/>
                  <c:y val="4.257489857731674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886D-4D9D-8F44-A6EF94D31BAB}"/>
                </c:ext>
              </c:extLst>
            </c:dLbl>
            <c:dLbl>
              <c:idx val="2"/>
              <c:layout>
                <c:manualLayout>
                  <c:x val="0"/>
                  <c:y val="-1.55746859845914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886D-4D9D-8F44-A6EF94D31BAB}"/>
                </c:ext>
              </c:extLst>
            </c:dLbl>
            <c:dLbl>
              <c:idx val="3"/>
              <c:layout>
                <c:manualLayout>
                  <c:x val="7.8682278951758347E-3"/>
                  <c:y val="1.241153276898312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886D-4D9D-8F44-A6EF94D31BAB}"/>
                </c:ext>
              </c:extLst>
            </c:dLbl>
            <c:dLbl>
              <c:idx val="4"/>
              <c:layout>
                <c:manualLayout>
                  <c:x val="-2.2245558460724509E-2"/>
                  <c:y val="3.6157156553674984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886D-4D9D-8F44-A6EF94D31BAB}"/>
                </c:ext>
              </c:extLst>
            </c:dLbl>
            <c:dLbl>
              <c:idx val="5"/>
              <c:layout>
                <c:manualLayout>
                  <c:x val="-3.2728184935094241E-3"/>
                  <c:y val="-1.746978919161396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969775716360623"/>
                      <c:h val="8.330891333170326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B-886D-4D9D-8F44-A6EF94D31BAB}"/>
                </c:ext>
              </c:extLst>
            </c:dLbl>
            <c:dLbl>
              <c:idx val="6"/>
              <c:layout>
                <c:manualLayout>
                  <c:x val="0.12402453821984555"/>
                  <c:y val="-3.2312581699346407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3087457742912779"/>
                      <c:h val="9.1657443060955412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D-886D-4D9D-8F44-A6EF94D31BAB}"/>
                </c:ext>
              </c:extLst>
            </c:dLbl>
            <c:dLbl>
              <c:idx val="7"/>
              <c:layout>
                <c:manualLayout>
                  <c:x val="0.16654679758977892"/>
                  <c:y val="-2.3631372549019609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344584988201038"/>
                      <c:h val="8.9409558579695375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F-886D-4D9D-8F44-A6EF94D31BAB}"/>
                </c:ext>
              </c:extLst>
            </c:dLbl>
            <c:dLbl>
              <c:idx val="8"/>
              <c:layout>
                <c:manualLayout>
                  <c:x val="0.23461538075735189"/>
                  <c:y val="-2.187352941176470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415634406102832"/>
                      <c:h val="8.2312226595559465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1-886D-4D9D-8F44-A6EF94D31BAB}"/>
                </c:ext>
              </c:extLst>
            </c:dLbl>
            <c:dLbl>
              <c:idx val="9"/>
              <c:layout>
                <c:manualLayout>
                  <c:x val="0.30210735521336873"/>
                  <c:y val="-5.3537581699346403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4181565038754324"/>
                      <c:h val="9.8010784313725466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3-886D-4D9D-8F44-A6EF94D31BAB}"/>
                </c:ext>
              </c:extLst>
            </c:dLbl>
            <c:dLbl>
              <c:idx val="10"/>
              <c:layout>
                <c:manualLayout>
                  <c:x val="0.34451342349761582"/>
                  <c:y val="4.921895424836600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886D-4D9D-8F44-A6EF94D31BAB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15_D!$A$5:$A$15</c:f>
              <c:strCache>
                <c:ptCount val="11"/>
                <c:pt idx="0">
                  <c:v>Lung</c:v>
                </c:pt>
                <c:pt idx="1">
                  <c:v>Liver</c:v>
                </c:pt>
                <c:pt idx="2">
                  <c:v>Stomach</c:v>
                </c:pt>
                <c:pt idx="3">
                  <c:v>Pancreas</c:v>
                </c:pt>
                <c:pt idx="4">
                  <c:v>Colorectal</c:v>
                </c:pt>
                <c:pt idx="5">
                  <c:v>Esophagus</c:v>
                </c:pt>
                <c:pt idx="6">
                  <c:v>Oral cavity/Pharynx</c:v>
                </c:pt>
                <c:pt idx="7">
                  <c:v>Bladder</c:v>
                </c:pt>
                <c:pt idx="8">
                  <c:v>Larynx</c:v>
                </c:pt>
                <c:pt idx="9">
                  <c:v>Kidney</c:v>
                </c:pt>
                <c:pt idx="10">
                  <c:v>Cervix uteri</c:v>
                </c:pt>
              </c:strCache>
            </c:strRef>
          </c:cat>
          <c:val>
            <c:numRef>
              <c:f>남녀_2015_D!$B$5:$B$15</c:f>
              <c:numCache>
                <c:formatCode>General</c:formatCode>
                <c:ptCount val="11"/>
                <c:pt idx="0">
                  <c:v>59.2</c:v>
                </c:pt>
                <c:pt idx="1">
                  <c:v>12.9</c:v>
                </c:pt>
                <c:pt idx="2">
                  <c:v>8.3000000000000007</c:v>
                </c:pt>
                <c:pt idx="3">
                  <c:v>5.3</c:v>
                </c:pt>
                <c:pt idx="4">
                  <c:v>4</c:v>
                </c:pt>
                <c:pt idx="5">
                  <c:v>3.5</c:v>
                </c:pt>
                <c:pt idx="6">
                  <c:v>2.2000000000000002</c:v>
                </c:pt>
                <c:pt idx="7">
                  <c:v>2</c:v>
                </c:pt>
                <c:pt idx="8">
                  <c:v>1.2</c:v>
                </c:pt>
                <c:pt idx="9">
                  <c:v>1</c:v>
                </c:pt>
                <c:pt idx="10">
                  <c:v>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886D-4D9D-8F44-A6EF94D31BAB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22F2-4D6B-B155-0946FEF326A7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22F2-4D6B-B155-0946FEF326A7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22F2-4D6B-B155-0946FEF326A7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22F2-4D6B-B155-0946FEF326A7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15_D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남자_2015_D!$B$1:$B$2</c:f>
              <c:numCache>
                <c:formatCode>General</c:formatCode>
                <c:ptCount val="2"/>
                <c:pt idx="0">
                  <c:v>67.900000000000006</c:v>
                </c:pt>
                <c:pt idx="1">
                  <c:v>32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2F2-4D6B-B155-0946FEF326A7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146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8531-414B-AFB6-5A29F755FAA2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8531-414B-AFB6-5A29F755FAA2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8531-414B-AFB6-5A29F755FAA2}"/>
              </c:ext>
            </c:extLst>
          </c:dPt>
          <c:dPt>
            <c:idx val="3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8531-414B-AFB6-5A29F755FAA2}"/>
              </c:ext>
            </c:extLst>
          </c:dPt>
          <c:dPt>
            <c:idx val="4"/>
            <c:bubble3D val="0"/>
            <c:spPr>
              <a:solidFill>
                <a:schemeClr val="dk1">
                  <a:tint val="3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8531-414B-AFB6-5A29F755FAA2}"/>
              </c:ext>
            </c:extLst>
          </c:dPt>
          <c:dPt>
            <c:idx val="5"/>
            <c:bubble3D val="0"/>
            <c:spPr>
              <a:solidFill>
                <a:schemeClr val="dk1">
                  <a:tint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8531-414B-AFB6-5A29F755FAA2}"/>
              </c:ext>
            </c:extLst>
          </c:dPt>
          <c:dPt>
            <c:idx val="6"/>
            <c:bubble3D val="0"/>
            <c:spPr>
              <a:solidFill>
                <a:schemeClr val="dk1">
                  <a:tint val="8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8531-414B-AFB6-5A29F755FAA2}"/>
              </c:ext>
            </c:extLst>
          </c:dPt>
          <c:dPt>
            <c:idx val="7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8531-414B-AFB6-5A29F755FAA2}"/>
              </c:ext>
            </c:extLst>
          </c:dPt>
          <c:dPt>
            <c:idx val="8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8531-414B-AFB6-5A29F755FAA2}"/>
              </c:ext>
            </c:extLst>
          </c:dPt>
          <c:dPt>
            <c:idx val="9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8531-414B-AFB6-5A29F755FAA2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9A358069-5A98-4D36-8568-3DB055DCD609}" type="VALU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값]</a:t>
                    </a:fld>
                    <a:r>
                      <a:rPr lang="en-US" altLang="ko-KR" baseline="0"/>
                      <a:t>%</a:t>
                    </a:r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8531-414B-AFB6-5A29F755FAA2}"/>
                </c:ext>
              </c:extLst>
            </c:dLbl>
            <c:dLbl>
              <c:idx val="1"/>
              <c:layout>
                <c:manualLayout>
                  <c:x val="0.2610699319822814"/>
                  <c:y val="4.257489857731674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8531-414B-AFB6-5A29F755FAA2}"/>
                </c:ext>
              </c:extLst>
            </c:dLbl>
            <c:dLbl>
              <c:idx val="2"/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6="http://schemas.microsoft.com/office/drawing/2014/chart" uri="{C3380CC4-5D6E-409C-BE32-E72D297353CC}">
                  <c16:uniqueId val="{00000005-8531-414B-AFB6-5A29F755FAA2}"/>
                </c:ext>
              </c:extLst>
            </c:dLbl>
            <c:dLbl>
              <c:idx val="3"/>
              <c:layout>
                <c:manualLayout>
                  <c:x val="7.8682278951758347E-3"/>
                  <c:y val="1.241153276898312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8531-414B-AFB6-5A29F755FAA2}"/>
                </c:ext>
              </c:extLst>
            </c:dLbl>
            <c:dLbl>
              <c:idx val="4"/>
              <c:layout>
                <c:manualLayout>
                  <c:x val="-2.2245450587018017E-2"/>
                  <c:y val="1.5776178953137997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8531-414B-AFB6-5A29F755FAA2}"/>
                </c:ext>
              </c:extLst>
            </c:dLbl>
            <c:dLbl>
              <c:idx val="5"/>
              <c:layout>
                <c:manualLayout>
                  <c:x val="-3.7117922824862329E-2"/>
                  <c:y val="-1.075376934949499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7164739842760984"/>
                      <c:h val="8.3308896312793868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B-8531-414B-AFB6-5A29F755FAA2}"/>
                </c:ext>
              </c:extLst>
            </c:dLbl>
            <c:dLbl>
              <c:idx val="6"/>
              <c:layout>
                <c:manualLayout>
                  <c:x val="9.1243865380358877E-2"/>
                  <c:y val="-2.1479887585655607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067431306405633"/>
                      <c:h val="9.6381726133318565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D-8531-414B-AFB6-5A29F755FAA2}"/>
                </c:ext>
              </c:extLst>
            </c:dLbl>
            <c:dLbl>
              <c:idx val="7"/>
              <c:layout>
                <c:manualLayout>
                  <c:x val="0.12494470729397739"/>
                  <c:y val="-1.340408666696831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3604166240946394"/>
                      <c:h val="8.9409799554565697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F-8531-414B-AFB6-5A29F755FAA2}"/>
                </c:ext>
              </c:extLst>
            </c:dLbl>
            <c:dLbl>
              <c:idx val="8"/>
              <c:layout>
                <c:manualLayout>
                  <c:x val="0.17554173538383697"/>
                  <c:y val="-1.4863897868518118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8531-414B-AFB6-5A29F755FAA2}"/>
                </c:ext>
              </c:extLst>
            </c:dLbl>
            <c:dLbl>
              <c:idx val="9"/>
              <c:layout>
                <c:manualLayout>
                  <c:x val="0.23418395621183805"/>
                  <c:y val="9.0330321875717462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017216043455323"/>
                      <c:h val="0.11341380645226161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3-8531-414B-AFB6-5A29F755FAA2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15_D!$A$5:$A$14</c:f>
              <c:strCache>
                <c:ptCount val="10"/>
                <c:pt idx="0">
                  <c:v>Lung</c:v>
                </c:pt>
                <c:pt idx="1">
                  <c:v>Liver</c:v>
                </c:pt>
                <c:pt idx="2">
                  <c:v>Stomach</c:v>
                </c:pt>
                <c:pt idx="3">
                  <c:v>Pancreas</c:v>
                </c:pt>
                <c:pt idx="4">
                  <c:v>Colorectal</c:v>
                </c:pt>
                <c:pt idx="5">
                  <c:v>Esophagus</c:v>
                </c:pt>
                <c:pt idx="6">
                  <c:v>Oral cavity/Pharynx</c:v>
                </c:pt>
                <c:pt idx="7">
                  <c:v>Bladder</c:v>
                </c:pt>
                <c:pt idx="8">
                  <c:v>Larynx</c:v>
                </c:pt>
                <c:pt idx="9">
                  <c:v>Kidney</c:v>
                </c:pt>
              </c:strCache>
            </c:strRef>
          </c:cat>
          <c:val>
            <c:numRef>
              <c:f>남자_2015_D!$B$5:$B$14</c:f>
              <c:numCache>
                <c:formatCode>General</c:formatCode>
                <c:ptCount val="10"/>
                <c:pt idx="0">
                  <c:v>59.8</c:v>
                </c:pt>
                <c:pt idx="1">
                  <c:v>13.2</c:v>
                </c:pt>
                <c:pt idx="2">
                  <c:v>8.5</c:v>
                </c:pt>
                <c:pt idx="3">
                  <c:v>4.7</c:v>
                </c:pt>
                <c:pt idx="4">
                  <c:v>3.8</c:v>
                </c:pt>
                <c:pt idx="5">
                  <c:v>3.4</c:v>
                </c:pt>
                <c:pt idx="6">
                  <c:v>2.2000000000000002</c:v>
                </c:pt>
                <c:pt idx="7">
                  <c:v>2.1</c:v>
                </c:pt>
                <c:pt idx="8">
                  <c:v>1.2</c:v>
                </c:pt>
                <c:pt idx="9">
                  <c:v>1.10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8531-414B-AFB6-5A29F755FAA2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372D-4106-A410-AA6BFF5C1848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372D-4106-A410-AA6BFF5C1848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372D-4106-A410-AA6BFF5C1848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372D-4106-A410-AA6BFF5C1848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15_D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여자_2015_D!$B$1:$B$2</c:f>
              <c:numCache>
                <c:formatCode>General</c:formatCode>
                <c:ptCount val="2"/>
                <c:pt idx="0">
                  <c:v>95.3</c:v>
                </c:pt>
                <c:pt idx="1">
                  <c:v>4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72D-4106-A410-AA6BFF5C1848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8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6727-470C-B3C9-1A6F31286AE3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6727-470C-B3C9-1A6F31286AE3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6727-470C-B3C9-1A6F31286AE3}"/>
              </c:ext>
            </c:extLst>
          </c:dPt>
          <c:dPt>
            <c:idx val="3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6727-470C-B3C9-1A6F31286AE3}"/>
              </c:ext>
            </c:extLst>
          </c:dPt>
          <c:dPt>
            <c:idx val="4"/>
            <c:bubble3D val="0"/>
            <c:spPr>
              <a:solidFill>
                <a:schemeClr val="dk1">
                  <a:tint val="3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6727-470C-B3C9-1A6F31286AE3}"/>
              </c:ext>
            </c:extLst>
          </c:dPt>
          <c:dPt>
            <c:idx val="5"/>
            <c:bubble3D val="0"/>
            <c:spPr>
              <a:solidFill>
                <a:schemeClr val="dk1">
                  <a:tint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6727-470C-B3C9-1A6F31286AE3}"/>
              </c:ext>
            </c:extLst>
          </c:dPt>
          <c:dPt>
            <c:idx val="6"/>
            <c:bubble3D val="0"/>
            <c:spPr>
              <a:solidFill>
                <a:schemeClr val="dk1">
                  <a:tint val="8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6727-470C-B3C9-1A6F31286AE3}"/>
              </c:ext>
            </c:extLst>
          </c:dPt>
          <c:dPt>
            <c:idx val="7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6727-470C-B3C9-1A6F31286AE3}"/>
              </c:ext>
            </c:extLst>
          </c:dPt>
          <c:dPt>
            <c:idx val="8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6727-470C-B3C9-1A6F31286AE3}"/>
              </c:ext>
            </c:extLst>
          </c:dPt>
          <c:dPt>
            <c:idx val="9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6727-470C-B3C9-1A6F31286AE3}"/>
              </c:ext>
            </c:extLst>
          </c:dPt>
          <c:dPt>
            <c:idx val="10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6727-470C-B3C9-1A6F31286AE3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9A358069-5A98-4D36-8568-3DB055DCD609}" type="VALU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값]</a:t>
                    </a:fld>
                    <a:r>
                      <a:rPr lang="en-US" altLang="ko-KR" baseline="0"/>
                      <a:t>%</a:t>
                    </a:r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6727-470C-B3C9-1A6F31286AE3}"/>
                </c:ext>
              </c:extLst>
            </c:dLbl>
            <c:dLbl>
              <c:idx val="1"/>
              <c:layout>
                <c:manualLayout>
                  <c:x val="0.2610699319822814"/>
                  <c:y val="4.257489857731674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6727-470C-B3C9-1A6F31286AE3}"/>
                </c:ext>
              </c:extLst>
            </c:dLbl>
            <c:dLbl>
              <c:idx val="2"/>
              <c:layout>
                <c:manualLayout>
                  <c:x val="0"/>
                  <c:y val="-1.55746859845914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6727-470C-B3C9-1A6F31286AE3}"/>
                </c:ext>
              </c:extLst>
            </c:dLbl>
            <c:dLbl>
              <c:idx val="3"/>
              <c:layout>
                <c:manualLayout>
                  <c:x val="3.6218182450431539E-3"/>
                  <c:y val="-4.984346405228762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6727-470C-B3C9-1A6F31286AE3}"/>
                </c:ext>
              </c:extLst>
            </c:dLbl>
            <c:dLbl>
              <c:idx val="4"/>
              <c:layout>
                <c:manualLayout>
                  <c:x val="1.2739224070914346E-2"/>
                  <c:y val="3.3251633986927723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6727-470C-B3C9-1A6F31286AE3}"/>
                </c:ext>
              </c:extLst>
            </c:dLbl>
            <c:dLbl>
              <c:idx val="5"/>
              <c:layout>
                <c:manualLayout>
                  <c:x val="-3.5072711432334001E-2"/>
                  <c:y val="2.971116622206252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9299673392569244"/>
                      <c:h val="8.3308934013918493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B-6727-470C-B3C9-1A6F31286AE3}"/>
                </c:ext>
              </c:extLst>
            </c:dLbl>
            <c:dLbl>
              <c:idx val="6"/>
              <c:layout>
                <c:manualLayout>
                  <c:x val="-0.1134974245936872"/>
                  <c:y val="3.1118713138504638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6727-470C-B3C9-1A6F31286AE3}"/>
                </c:ext>
              </c:extLst>
            </c:dLbl>
            <c:dLbl>
              <c:idx val="7"/>
              <c:layout>
                <c:manualLayout>
                  <c:x val="-4.5751201282080857E-2"/>
                  <c:y val="-2.063055555555555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8881030592095108"/>
                      <c:h val="8.9409734730599308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F-6727-470C-B3C9-1A6F31286AE3}"/>
                </c:ext>
              </c:extLst>
            </c:dLbl>
            <c:dLbl>
              <c:idx val="8"/>
              <c:layout>
                <c:manualLayout>
                  <c:x val="5.6006109477748575E-2"/>
                  <c:y val="-1.2450816993464052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415631395734133"/>
                      <c:h val="9.3200326797385602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1-6727-470C-B3C9-1A6F31286AE3}"/>
                </c:ext>
              </c:extLst>
            </c:dLbl>
            <c:dLbl>
              <c:idx val="9"/>
              <c:layout>
                <c:manualLayout>
                  <c:x val="0.1299822152407262"/>
                  <c:y val="-1.2450816993464052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7136563478951691"/>
                      <c:h val="8.3405228758169928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3-6727-470C-B3C9-1A6F31286AE3}"/>
                </c:ext>
              </c:extLst>
            </c:dLbl>
            <c:dLbl>
              <c:idx val="10"/>
              <c:layout>
                <c:manualLayout>
                  <c:x val="0.21706534419477555"/>
                  <c:y val="6.9147058823529365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6727-470C-B3C9-1A6F31286AE3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15_D!$A$5:$A$15</c:f>
              <c:strCache>
                <c:ptCount val="11"/>
                <c:pt idx="0">
                  <c:v>Lung</c:v>
                </c:pt>
                <c:pt idx="1">
                  <c:v>Pancreas</c:v>
                </c:pt>
                <c:pt idx="2">
                  <c:v>Liver</c:v>
                </c:pt>
                <c:pt idx="3">
                  <c:v>Stomach</c:v>
                </c:pt>
                <c:pt idx="4">
                  <c:v>Colorectal</c:v>
                </c:pt>
                <c:pt idx="5">
                  <c:v>Cervix uteri</c:v>
                </c:pt>
                <c:pt idx="6">
                  <c:v>Esophagus</c:v>
                </c:pt>
                <c:pt idx="7">
                  <c:v>Oral cavity/Pharynx</c:v>
                </c:pt>
                <c:pt idx="8">
                  <c:v>Bladder</c:v>
                </c:pt>
                <c:pt idx="9">
                  <c:v>Larynx</c:v>
                </c:pt>
                <c:pt idx="10">
                  <c:v>Kidney</c:v>
                </c:pt>
              </c:strCache>
            </c:strRef>
          </c:cat>
          <c:val>
            <c:numRef>
              <c:f>여자_2015_D!$B$5:$B$15</c:f>
              <c:numCache>
                <c:formatCode>General</c:formatCode>
                <c:ptCount val="11"/>
                <c:pt idx="0">
                  <c:v>52.7</c:v>
                </c:pt>
                <c:pt idx="1">
                  <c:v>12.1</c:v>
                </c:pt>
                <c:pt idx="2">
                  <c:v>9.5</c:v>
                </c:pt>
                <c:pt idx="3">
                  <c:v>6.4</c:v>
                </c:pt>
                <c:pt idx="4">
                  <c:v>5.9</c:v>
                </c:pt>
                <c:pt idx="5">
                  <c:v>4.5999999999999996</c:v>
                </c:pt>
                <c:pt idx="6">
                  <c:v>4.3</c:v>
                </c:pt>
                <c:pt idx="7">
                  <c:v>1.4</c:v>
                </c:pt>
                <c:pt idx="8">
                  <c:v>1.1000000000000001</c:v>
                </c:pt>
                <c:pt idx="9">
                  <c:v>1</c:v>
                </c:pt>
                <c:pt idx="1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6727-470C-B3C9-1A6F31286AE3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5397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0712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9746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5050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159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4482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5682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7142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9130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7685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2220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4086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C182B7A1-D882-445E-9C5E-D8969AA97ACD}"/>
              </a:ext>
            </a:extLst>
          </p:cNvPr>
          <p:cNvGrpSpPr/>
          <p:nvPr/>
        </p:nvGrpSpPr>
        <p:grpSpPr>
          <a:xfrm>
            <a:off x="515254" y="411558"/>
            <a:ext cx="5839006" cy="9236773"/>
            <a:chOff x="515254" y="620837"/>
            <a:chExt cx="5839006" cy="9236773"/>
          </a:xfrm>
        </p:grpSpPr>
        <p:sp>
          <p:nvSpPr>
            <p:cNvPr id="53" name="직사각형 52">
              <a:extLst>
                <a:ext uri="{FF2B5EF4-FFF2-40B4-BE49-F238E27FC236}">
                  <a16:creationId xmlns:a16="http://schemas.microsoft.com/office/drawing/2014/main" id="{E9FFEC05-C143-45B5-A6AA-E9F7914DFFBF}"/>
                </a:ext>
              </a:extLst>
            </p:cNvPr>
            <p:cNvSpPr/>
            <p:nvPr/>
          </p:nvSpPr>
          <p:spPr>
            <a:xfrm>
              <a:off x="619557" y="9303612"/>
              <a:ext cx="5630400" cy="553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Material 10. The population attributable fraction (%) of cancer deaths attributed to tobacco smoking and proportion of specific cancers among all-cancer deaths caused by tobacco smoking in Korea, 2015.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3" name="그룹 12">
              <a:extLst>
                <a:ext uri="{FF2B5EF4-FFF2-40B4-BE49-F238E27FC236}">
                  <a16:creationId xmlns:a16="http://schemas.microsoft.com/office/drawing/2014/main" id="{D60EAC2D-4F26-435A-B733-AF8C29F85205}"/>
                </a:ext>
              </a:extLst>
            </p:cNvPr>
            <p:cNvGrpSpPr/>
            <p:nvPr/>
          </p:nvGrpSpPr>
          <p:grpSpPr>
            <a:xfrm>
              <a:off x="515254" y="620837"/>
              <a:ext cx="5839006" cy="8856000"/>
              <a:chOff x="515254" y="620837"/>
              <a:chExt cx="5839006" cy="8881607"/>
            </a:xfrm>
          </p:grpSpPr>
          <p:grpSp>
            <p:nvGrpSpPr>
              <p:cNvPr id="9" name="그룹 8">
                <a:extLst>
                  <a:ext uri="{FF2B5EF4-FFF2-40B4-BE49-F238E27FC236}">
                    <a16:creationId xmlns:a16="http://schemas.microsoft.com/office/drawing/2014/main" id="{024808BA-5023-448C-A6D5-4AEDB6660F3D}"/>
                  </a:ext>
                </a:extLst>
              </p:cNvPr>
              <p:cNvGrpSpPr/>
              <p:nvPr/>
            </p:nvGrpSpPr>
            <p:grpSpPr>
              <a:xfrm>
                <a:off x="515254" y="620837"/>
                <a:ext cx="5801876" cy="3142748"/>
                <a:chOff x="515254" y="620837"/>
                <a:chExt cx="5801876" cy="3142748"/>
              </a:xfrm>
            </p:grpSpPr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ED0E3951-E7A8-4D37-953A-49C87951C1DC}"/>
                    </a:ext>
                  </a:extLst>
                </p:cNvPr>
                <p:cNvSpPr txBox="1"/>
                <p:nvPr/>
              </p:nvSpPr>
              <p:spPr>
                <a:xfrm>
                  <a:off x="515254" y="620837"/>
                  <a:ext cx="158248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otal cancer deaths, 2015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69" name="그룹 68">
                  <a:extLst>
                    <a:ext uri="{FF2B5EF4-FFF2-40B4-BE49-F238E27FC236}">
                      <a16:creationId xmlns:a16="http://schemas.microsoft.com/office/drawing/2014/main" id="{5BF6C7C5-F313-431B-BA19-A604DBF52E2C}"/>
                    </a:ext>
                  </a:extLst>
                </p:cNvPr>
                <p:cNvGrpSpPr/>
                <p:nvPr/>
              </p:nvGrpSpPr>
              <p:grpSpPr>
                <a:xfrm>
                  <a:off x="633054" y="680594"/>
                  <a:ext cx="5684076" cy="3082991"/>
                  <a:chOff x="0" y="10698"/>
                  <a:chExt cx="5684076" cy="3082991"/>
                </a:xfrm>
              </p:grpSpPr>
              <p:grpSp>
                <p:nvGrpSpPr>
                  <p:cNvPr id="70" name="그룹 69">
                    <a:extLst>
                      <a:ext uri="{FF2B5EF4-FFF2-40B4-BE49-F238E27FC236}">
                        <a16:creationId xmlns:a16="http://schemas.microsoft.com/office/drawing/2014/main" id="{4A635C01-BB98-4232-A317-F49F62E88C57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10698"/>
                    <a:ext cx="5684076" cy="3082991"/>
                    <a:chOff x="0" y="12421"/>
                    <a:chExt cx="6079509" cy="3579573"/>
                  </a:xfrm>
                </p:grpSpPr>
                <p:grpSp>
                  <p:nvGrpSpPr>
                    <p:cNvPr id="72" name="그룹 71">
                      <a:extLst>
                        <a:ext uri="{FF2B5EF4-FFF2-40B4-BE49-F238E27FC236}">
                          <a16:creationId xmlns:a16="http://schemas.microsoft.com/office/drawing/2014/main" id="{DDC66F9D-767A-4D58-9C1C-A936CEAE1B4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12421"/>
                      <a:ext cx="6079509" cy="3579573"/>
                      <a:chOff x="0" y="14361"/>
                      <a:chExt cx="11043038" cy="4138820"/>
                    </a:xfrm>
                  </p:grpSpPr>
                  <p:graphicFrame>
                    <p:nvGraphicFramePr>
                      <p:cNvPr id="74" name="차트 73">
                        <a:extLst>
                          <a:ext uri="{FF2B5EF4-FFF2-40B4-BE49-F238E27FC236}">
                            <a16:creationId xmlns:a16="http://schemas.microsoft.com/office/drawing/2014/main" id="{A33E380A-4359-426E-9FCD-D7262F5FE222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2"/>
                      </a:graphicData>
                    </a:graphic>
                  </p:graphicFrame>
                  <p:graphicFrame>
                    <p:nvGraphicFramePr>
                      <p:cNvPr id="75" name="차트 74">
                        <a:extLst>
                          <a:ext uri="{FF2B5EF4-FFF2-40B4-BE49-F238E27FC236}">
                            <a16:creationId xmlns:a16="http://schemas.microsoft.com/office/drawing/2014/main" id="{38F76E96-FD53-4524-8843-D2847CBE7B1C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5211131" y="14361"/>
                      <a:ext cx="5831907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3"/>
                      </a:graphicData>
                    </a:graphic>
                  </p:graphicFrame>
                </p:grpSp>
                <p:cxnSp>
                  <p:nvCxnSpPr>
                    <p:cNvPr id="73" name="직선 연결선 72">
                      <a:extLst>
                        <a:ext uri="{FF2B5EF4-FFF2-40B4-BE49-F238E27FC236}">
                          <a16:creationId xmlns:a16="http://schemas.microsoft.com/office/drawing/2014/main" id="{3E073091-FEB1-4C93-A1B7-66B285C979B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105941" y="2401810"/>
                      <a:ext cx="2077854" cy="766318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71" name="직선 연결선 70">
                    <a:extLst>
                      <a:ext uri="{FF2B5EF4-FFF2-40B4-BE49-F238E27FC236}">
                        <a16:creationId xmlns:a16="http://schemas.microsoft.com/office/drawing/2014/main" id="{4FB99366-EB48-4E50-BECB-B4F8A17638B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1944353" y="371118"/>
                    <a:ext cx="1933903" cy="588580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2" name="그룹 11">
                <a:extLst>
                  <a:ext uri="{FF2B5EF4-FFF2-40B4-BE49-F238E27FC236}">
                    <a16:creationId xmlns:a16="http://schemas.microsoft.com/office/drawing/2014/main" id="{EE1B23AE-30D7-47E9-B02A-6574FDEAA0AD}"/>
                  </a:ext>
                </a:extLst>
              </p:cNvPr>
              <p:cNvGrpSpPr/>
              <p:nvPr/>
            </p:nvGrpSpPr>
            <p:grpSpPr>
              <a:xfrm>
                <a:off x="515254" y="3521381"/>
                <a:ext cx="5839006" cy="3034259"/>
                <a:chOff x="515254" y="3521381"/>
                <a:chExt cx="5839006" cy="3034259"/>
              </a:xfrm>
            </p:grpSpPr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258A911A-63B4-40A6-978C-8464EFBD17F1}"/>
                    </a:ext>
                  </a:extLst>
                </p:cNvPr>
                <p:cNvSpPr txBox="1"/>
                <p:nvPr/>
              </p:nvSpPr>
              <p:spPr>
                <a:xfrm>
                  <a:off x="515254" y="3521381"/>
                  <a:ext cx="1569660" cy="24693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le cancer deaths, 2015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56" name="그룹 55">
                  <a:extLst>
                    <a:ext uri="{FF2B5EF4-FFF2-40B4-BE49-F238E27FC236}">
                      <a16:creationId xmlns:a16="http://schemas.microsoft.com/office/drawing/2014/main" id="{90ECEDD1-876D-4246-B276-A86E60FDD5F2}"/>
                    </a:ext>
                  </a:extLst>
                </p:cNvPr>
                <p:cNvGrpSpPr/>
                <p:nvPr/>
              </p:nvGrpSpPr>
              <p:grpSpPr>
                <a:xfrm>
                  <a:off x="633054" y="3572035"/>
                  <a:ext cx="5721206" cy="2983605"/>
                  <a:chOff x="0" y="0"/>
                  <a:chExt cx="5717829" cy="3298742"/>
                </a:xfrm>
              </p:grpSpPr>
              <p:grpSp>
                <p:nvGrpSpPr>
                  <p:cNvPr id="57" name="그룹 56">
                    <a:extLst>
                      <a:ext uri="{FF2B5EF4-FFF2-40B4-BE49-F238E27FC236}">
                        <a16:creationId xmlns:a16="http://schemas.microsoft.com/office/drawing/2014/main" id="{A2ED4DA5-1FB4-4A92-BEB5-49925F9FE9A5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17829" cy="3298742"/>
                    <a:chOff x="0" y="0"/>
                    <a:chExt cx="5695116" cy="3251851"/>
                  </a:xfrm>
                </p:grpSpPr>
                <p:grpSp>
                  <p:nvGrpSpPr>
                    <p:cNvPr id="59" name="그룹 58">
                      <a:extLst>
                        <a:ext uri="{FF2B5EF4-FFF2-40B4-BE49-F238E27FC236}">
                          <a16:creationId xmlns:a16="http://schemas.microsoft.com/office/drawing/2014/main" id="{42271E34-759A-4BB6-A716-4EB61875ECF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5695116" cy="3251851"/>
                      <a:chOff x="0" y="0"/>
                      <a:chExt cx="11105322" cy="4138820"/>
                    </a:xfrm>
                  </p:grpSpPr>
                  <p:graphicFrame>
                    <p:nvGraphicFramePr>
                      <p:cNvPr id="61" name="차트 60">
                        <a:extLst>
                          <a:ext uri="{FF2B5EF4-FFF2-40B4-BE49-F238E27FC236}">
                            <a16:creationId xmlns:a16="http://schemas.microsoft.com/office/drawing/2014/main" id="{505614E0-2C93-4F8C-A225-63D6DB5D8813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4"/>
                      </a:graphicData>
                    </a:graphic>
                  </p:graphicFrame>
                  <p:graphicFrame>
                    <p:nvGraphicFramePr>
                      <p:cNvPr id="62" name="차트 61">
                        <a:extLst>
                          <a:ext uri="{FF2B5EF4-FFF2-40B4-BE49-F238E27FC236}">
                            <a16:creationId xmlns:a16="http://schemas.microsoft.com/office/drawing/2014/main" id="{C7CDF827-55A3-4F1F-83AD-C219D435E16D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5273413" y="0"/>
                      <a:ext cx="5831909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5"/>
                      </a:graphicData>
                    </a:graphic>
                  </p:graphicFrame>
                </p:grpSp>
                <p:cxnSp>
                  <p:nvCxnSpPr>
                    <p:cNvPr id="60" name="직선 연결선 59">
                      <a:extLst>
                        <a:ext uri="{FF2B5EF4-FFF2-40B4-BE49-F238E27FC236}">
                          <a16:creationId xmlns:a16="http://schemas.microsoft.com/office/drawing/2014/main" id="{D7515FE8-F6D5-4E38-AC3D-8E26E393EE9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746206" y="2365131"/>
                      <a:ext cx="2072798" cy="514241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58" name="직선 연결선 57">
                    <a:extLst>
                      <a:ext uri="{FF2B5EF4-FFF2-40B4-BE49-F238E27FC236}">
                        <a16:creationId xmlns:a16="http://schemas.microsoft.com/office/drawing/2014/main" id="{AA2B71FC-B814-448F-B76A-B4514765264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1715873" y="356809"/>
                    <a:ext cx="2138230" cy="522847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5" name="그룹 4">
                <a:extLst>
                  <a:ext uri="{FF2B5EF4-FFF2-40B4-BE49-F238E27FC236}">
                    <a16:creationId xmlns:a16="http://schemas.microsoft.com/office/drawing/2014/main" id="{CF53EE07-E1DD-4F4A-942D-05B0B7719DA9}"/>
                  </a:ext>
                </a:extLst>
              </p:cNvPr>
              <p:cNvGrpSpPr/>
              <p:nvPr/>
            </p:nvGrpSpPr>
            <p:grpSpPr>
              <a:xfrm>
                <a:off x="515254" y="6442444"/>
                <a:ext cx="5825961" cy="3060000"/>
                <a:chOff x="515254" y="6442444"/>
                <a:chExt cx="5825961" cy="3060000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1CCE139B-33F4-42FE-852F-5255F617D6FF}"/>
                    </a:ext>
                  </a:extLst>
                </p:cNvPr>
                <p:cNvSpPr txBox="1"/>
                <p:nvPr/>
              </p:nvSpPr>
              <p:spPr>
                <a:xfrm>
                  <a:off x="515254" y="6538005"/>
                  <a:ext cx="17187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emale cancer deaths, 2015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63" name="그룹 62">
                  <a:extLst>
                    <a:ext uri="{FF2B5EF4-FFF2-40B4-BE49-F238E27FC236}">
                      <a16:creationId xmlns:a16="http://schemas.microsoft.com/office/drawing/2014/main" id="{C5F29C6B-7ABB-4FBA-ADBE-3FA29E77329E}"/>
                    </a:ext>
                  </a:extLst>
                </p:cNvPr>
                <p:cNvGrpSpPr/>
                <p:nvPr/>
              </p:nvGrpSpPr>
              <p:grpSpPr>
                <a:xfrm>
                  <a:off x="646100" y="6442444"/>
                  <a:ext cx="5695115" cy="3060000"/>
                  <a:chOff x="0" y="0"/>
                  <a:chExt cx="5708367" cy="3214577"/>
                </a:xfrm>
              </p:grpSpPr>
              <p:grpSp>
                <p:nvGrpSpPr>
                  <p:cNvPr id="64" name="그룹 63">
                    <a:extLst>
                      <a:ext uri="{FF2B5EF4-FFF2-40B4-BE49-F238E27FC236}">
                        <a16:creationId xmlns:a16="http://schemas.microsoft.com/office/drawing/2014/main" id="{2808C576-9E4E-481B-BB67-123CE43F7E96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08367" cy="3214577"/>
                    <a:chOff x="0" y="0"/>
                    <a:chExt cx="11105322" cy="4138820"/>
                  </a:xfrm>
                </p:grpSpPr>
                <p:graphicFrame>
                  <p:nvGraphicFramePr>
                    <p:cNvPr id="67" name="차트 66">
                      <a:extLst>
                        <a:ext uri="{FF2B5EF4-FFF2-40B4-BE49-F238E27FC236}">
                          <a16:creationId xmlns:a16="http://schemas.microsoft.com/office/drawing/2014/main" id="{1209E2DE-2E16-4EC2-9FF4-9DFCDCFFDA4F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0" y="652478"/>
                    <a:ext cx="4681538" cy="2833864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6"/>
                    </a:graphicData>
                  </a:graphic>
                </p:graphicFrame>
                <p:graphicFrame>
                  <p:nvGraphicFramePr>
                    <p:cNvPr id="68" name="차트 67">
                      <a:extLst>
                        <a:ext uri="{FF2B5EF4-FFF2-40B4-BE49-F238E27FC236}">
                          <a16:creationId xmlns:a16="http://schemas.microsoft.com/office/drawing/2014/main" id="{BF3768B6-DC8F-4234-BB3A-6A3E549B5D56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5273414" y="0"/>
                    <a:ext cx="5831908" cy="413882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7"/>
                    </a:graphicData>
                  </a:graphic>
                </p:graphicFrame>
              </p:grpSp>
              <p:cxnSp>
                <p:nvCxnSpPr>
                  <p:cNvPr id="65" name="직선 연결선 64">
                    <a:extLst>
                      <a:ext uri="{FF2B5EF4-FFF2-40B4-BE49-F238E27FC236}">
                        <a16:creationId xmlns:a16="http://schemas.microsoft.com/office/drawing/2014/main" id="{F45900C4-C179-4E71-AE35-4868641359C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80758" y="357950"/>
                    <a:ext cx="1826933" cy="1082428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6" name="직선 연결선 65">
                    <a:extLst>
                      <a:ext uri="{FF2B5EF4-FFF2-40B4-BE49-F238E27FC236}">
                        <a16:creationId xmlns:a16="http://schemas.microsoft.com/office/drawing/2014/main" id="{91CA178B-31A1-4CB7-A146-19A0C504166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95386" y="1747669"/>
                    <a:ext cx="1778891" cy="1111821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</p:spTree>
    <p:extLst>
      <p:ext uri="{BB962C8B-B14F-4D97-AF65-F5344CB8AC3E}">
        <p14:creationId xmlns:p14="http://schemas.microsoft.com/office/powerpoint/2010/main" val="1828824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159</Words>
  <Application>Microsoft Office PowerPoint</Application>
  <PresentationFormat>A4 용지(210x297mm)</PresentationFormat>
  <Paragraphs>4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seul Sung</dc:creator>
  <cp:lastModifiedBy>이제인</cp:lastModifiedBy>
  <cp:revision>16</cp:revision>
  <dcterms:created xsi:type="dcterms:W3CDTF">2024-07-22T05:46:04Z</dcterms:created>
  <dcterms:modified xsi:type="dcterms:W3CDTF">2025-09-26T00:05:52Z</dcterms:modified>
</cp:coreProperties>
</file>